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41" autoAdjust="0"/>
    <p:restoredTop sz="96127" autoAdjust="0"/>
  </p:normalViewPr>
  <p:slideViewPr>
    <p:cSldViewPr snapToGrid="0">
      <p:cViewPr varScale="1">
        <p:scale>
          <a:sx n="73" d="100"/>
          <a:sy n="73" d="100"/>
        </p:scale>
        <p:origin x="50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02DCE4-AC42-44B5-8D03-0DE95135CD72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884185-0280-4899-8925-440DE2A3CC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9342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884185-0280-4899-8925-440DE2A3CC2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453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9094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900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004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731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0255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254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613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978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6551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6716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3526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7589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1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1186191"/>
              </p:ext>
            </p:extLst>
          </p:nvPr>
        </p:nvGraphicFramePr>
        <p:xfrm>
          <a:off x="218425" y="877104"/>
          <a:ext cx="6217099" cy="64124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238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353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353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25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09025">
                <a:tc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87" marR="91487"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atients with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CV even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n = 64)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atients withou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CV even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n = 308)</a:t>
                      </a:r>
                      <a:endParaRPr lang="ko-KR" altLang="ko-KR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</a:t>
                      </a:r>
                      <a:endParaRPr lang="ko-KR" altLang="ko-KR" sz="1200" b="1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4093">
                <a:tc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87" marR="91487"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20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Age (year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65.6±11.9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60.0±12.6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001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Male (%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8 (59.4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04 (66.2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295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6152780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BMI (kg/m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2.7±3.3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3.5±4.4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85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Dialysis duration (year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4.1±4.9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.8±5.6</a:t>
                      </a:r>
                      <a:endParaRPr lang="ko-KR" altLang="en-US" sz="12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547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harlso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comorbidity scor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4.8±1.5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.9±1.5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&lt;0.001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History of CV disease (%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40 (62.5)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15 (37.3)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  <a:endParaRPr lang="ko-KR" altLang="en-US" sz="120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Hemoglobin (g/d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0.3±1.2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0.5±1.2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06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Albumin (g/d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.76±0.27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.82±0.32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68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3716380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LDL-cholesterol (mg/d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78.0±28.2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76.1±25.8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608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sCR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(mg/d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4.37±6.43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4.14±8.24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36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120343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Pre-dialysis SBP (mmHg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42.5±19.2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44.3±20.0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481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231384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K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/V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61±0.30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59±0.28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547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Intact PTH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94.3±207.6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94.8±227.5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7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566976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Follow up months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4±13.8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3±14.5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NT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BN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g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/m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47.7 (234.9, 474.5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311.3 (196.3, 446.8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241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95068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MMP-2 (ng/m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736.5 (643.8, 830.3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56.5 (558.3, 781.3)</a:t>
                      </a:r>
                      <a:endParaRPr lang="ko-KR" altLang="en-US" sz="120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004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9234067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MMP-9 (ng/m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56.5 (39.0, 92.8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51.0 (33.0, 76.0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03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0253778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Tenascin-C (ng/m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9.8 (17.3, 21.5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9.7 (16.4, 23.8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662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862828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Thrombospondin-2 (ng/mL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5.0 (16.6, 33.6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5.1 (18.3, 36.6)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724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2288" name="직사각형 4"/>
          <p:cNvSpPr>
            <a:spLocks noChangeArrowheads="1"/>
          </p:cNvSpPr>
          <p:nvPr/>
        </p:nvSpPr>
        <p:spPr bwMode="auto">
          <a:xfrm>
            <a:off x="220061" y="118363"/>
            <a:ext cx="6215463" cy="61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upplementary</a:t>
            </a:r>
            <a:r>
              <a:rPr lang="ko-KR" altLang="en-US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Table 1. 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aseline demographic and laboratory data of the study population</a:t>
            </a:r>
            <a:endParaRPr lang="ko-KR" altLang="ko-KR" sz="12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218425" y="7312910"/>
            <a:ext cx="6217099" cy="1166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MI, body mass index; CV, cardiovascular; LDL, low-density lipoprotein cholesterol; </a:t>
            </a:r>
            <a:r>
              <a:rPr lang="en-US" altLang="ko-KR" sz="12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sCRP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, high-sensitivity C-reactive protein; SBP, systolic blood pressure; </a:t>
            </a:r>
            <a:r>
              <a:rPr lang="en-US" altLang="ko-KR" sz="12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pKt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/V, single-pool </a:t>
            </a:r>
            <a:r>
              <a:rPr lang="en-US" altLang="ko-KR" sz="12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t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/V; PTH, parathyroid hormone; MMP, matrix metalloproteinase; NT-</a:t>
            </a:r>
            <a:r>
              <a:rPr lang="en-US" altLang="ko-KR" sz="12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proBNP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, N-terminal fragment of brain natriuretic peptide.</a:t>
            </a:r>
          </a:p>
        </p:txBody>
      </p:sp>
    </p:spTree>
    <p:extLst>
      <p:ext uri="{BB962C8B-B14F-4D97-AF65-F5344CB8AC3E}">
        <p14:creationId xmlns:p14="http://schemas.microsoft.com/office/powerpoint/2010/main" val="3483311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4</TotalTime>
  <Words>321</Words>
  <Application>Microsoft Office PowerPoint</Application>
  <PresentationFormat>화면 슬라이드 쇼(4:3)</PresentationFormat>
  <Paragraphs>86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이유호</cp:lastModifiedBy>
  <cp:revision>484</cp:revision>
  <dcterms:created xsi:type="dcterms:W3CDTF">2019-03-14T08:36:26Z</dcterms:created>
  <dcterms:modified xsi:type="dcterms:W3CDTF">2023-12-20T14:24:03Z</dcterms:modified>
</cp:coreProperties>
</file>